
<file path=[Content_Types].xml><?xml version="1.0" encoding="utf-8"?>
<Types xmlns="http://schemas.openxmlformats.org/package/2006/content-types">
  <Default Extension="Acetate" ContentType="image/png"/>
  <Default Extension="butanol" ContentType="image/png"/>
  <Default Extension="Butanone" ContentType="image/png"/>
  <Default Extension="Disulfide" ContentType="image/png"/>
  <Default Extension="Ethylfuran" ContentType="image/png"/>
  <Default Extension="jpeg" ContentType="image/jpeg"/>
  <Default Extension="Methylbutanal" ContentType="image/pn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75" r:id="rId4"/>
    <p:sldId id="276" r:id="rId5"/>
    <p:sldId id="300" r:id="rId6"/>
    <p:sldId id="293" r:id="rId7"/>
    <p:sldId id="301" r:id="rId8"/>
    <p:sldId id="296" r:id="rId9"/>
    <p:sldId id="278" r:id="rId10"/>
    <p:sldId id="280" r:id="rId11"/>
    <p:sldId id="281" r:id="rId12"/>
    <p:sldId id="282" r:id="rId13"/>
    <p:sldId id="283" r:id="rId14"/>
    <p:sldId id="284" r:id="rId15"/>
    <p:sldId id="285" r:id="rId16"/>
    <p:sldId id="286" r:id="rId17"/>
    <p:sldId id="287" r:id="rId18"/>
    <p:sldId id="268" r:id="rId19"/>
    <p:sldId id="297" r:id="rId20"/>
    <p:sldId id="294" r:id="rId21"/>
    <p:sldId id="270" r:id="rId22"/>
    <p:sldId id="277" r:id="rId23"/>
    <p:sldId id="298" r:id="rId24"/>
    <p:sldId id="299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0A56E-26D4-9F85-7458-5AAC446120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17BC08-4CA7-EED3-B41E-A69316563D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B56D96-DC21-57F8-811B-C0C610952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097EAB-1E00-CF21-BBDE-CD98A00FF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2FBC0-1110-D42C-7CCF-6C040A39D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629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024D84-E357-EE5B-27DA-85F13A4C3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D8A944-923A-7CBF-2F92-A595941BB2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1D1E9C-353A-3D0C-1A29-E9FCD53F0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0ADCCA-6AF0-BDFE-93D4-3A3766A08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98A75-7E8C-589C-B713-15DD2F4C6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2833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1BCA86-3488-8B7A-004C-C0913A99C3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8F5C90-81C5-15C7-1D90-D97FEB2C2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31B7F2-0F73-0200-E21E-A1F7C1159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74D4E-1CF2-B4E5-135E-25FEF22E3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9C8DA-319A-997B-62AD-DE83C9CDE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395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BCA201-3D1C-FCA4-709C-7C4D6DB548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4E3C86-5DEF-4983-8AEC-B9D331312A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E480BF-3919-12AF-5046-29FD72A4A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97ECB-40A5-0D3B-4A22-4CB9F96BC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B4494-91A4-916F-C785-7595CD5BF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8979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D3981-F135-9083-7E27-72AE3D9A0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07F595-109A-DBC1-B3D2-1E300E2FC4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6D5630-45BE-F27B-46DC-AB8A6BA28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011B85-78F5-755D-2E2D-6BBF67FAF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AD4D92-2AD6-56D3-501B-B464C8343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645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5735C5-030B-46FD-5EEB-005B48E139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7151D0-C75F-0FB6-B3CD-8F01E69A62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157748-CDF7-783B-72C2-818DAE02E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8C2B99-785C-9E71-CD96-9A3F92424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9D879C-315E-D6B4-D750-D05A248D0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96F706-D3FB-9BA8-1AE8-CC4699DC2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4798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9C2DA-9FEE-EC00-0607-015573907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B1E827-4C94-C63A-5031-886A147C8A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FF6187-E301-3B96-0378-338D654648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10E3CE-BC90-543D-195E-340BFD6EB1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7DE1AF-BB5E-732C-0628-9DE34B6C10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E5CD97-8DD1-B978-64C2-6970ADD75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FC8088A-FCC8-DBA6-EAD9-C04CDF5B3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C3B0B92-7350-7BDA-8FC9-57294657F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434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8E00B-BC0F-0B8D-0D9D-6A56BA61A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F68E34-54AC-B984-1409-10B3B2C77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E6E6FE-5839-7417-E979-470E028F0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57A85B-322F-010E-46C2-64F38768C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058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ADB1C6-7863-3CB1-AFC0-A50838FF4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CB4BB0-4D76-4DBE-1CF6-19DE03CEA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3B14F2-4370-A252-A691-2C86B6FF7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183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9FA88-6B64-5A2D-1F2A-BBA28A5EB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73806-0DC3-A3F2-9380-10E9AD14F4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30BB02-B97D-6CDE-8915-69A978C19F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C188CE-4C32-4135-2194-95A109CC7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A0416E-44D9-52E2-226E-BD258A77E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378B67-4D2F-5AD9-F97D-08F443F06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198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72A03B-BCE2-3848-AF11-C87AEF73C8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5B5EBF-1334-A85B-2FEB-9AE3EAC312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6913A5-FA4E-5EB1-769C-012CC4AF23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5F5FB0-AEC2-AF54-5F1A-7F74557D2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78010A-B69C-FC83-2B81-0168F6430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A6B401-37FD-AE4E-DDA2-A8B9E3E56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0253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123ACA-B262-CFA6-F8C8-58BEF93352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E066F5-FFA8-7096-7E00-5C2FF1082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6A41D2-7C40-F243-C90B-E9A9C4742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2632B7-60FE-4CE0-BC00-2151BFB0DDE1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4CDE6F-D34A-387E-062F-68239E5E53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C018C2-0C14-0C90-7272-110AD95A70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AE45BD-7EEB-4777-99E7-2C00B0A85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84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thylfuran"/><Relationship Id="rId2" Type="http://schemas.openxmlformats.org/officeDocument/2006/relationships/image" Target="../media/image40.Butanone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butanol"/><Relationship Id="rId5" Type="http://schemas.openxmlformats.org/officeDocument/2006/relationships/image" Target="../media/image43.Methylbutanal"/><Relationship Id="rId4" Type="http://schemas.openxmlformats.org/officeDocument/2006/relationships/image" Target="../media/image42.Methylbutana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Acetate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Disulfide"/><Relationship Id="rId4" Type="http://schemas.openxmlformats.org/officeDocument/2006/relationships/image" Target="../media/image4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tif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AE60064-28E9-8A0B-27F7-B77A8FCDF1B2}"/>
              </a:ext>
            </a:extLst>
          </p:cNvPr>
          <p:cNvGraphicFramePr>
            <a:graphicFrameLocks noGrp="1"/>
          </p:cNvGraphicFramePr>
          <p:nvPr/>
        </p:nvGraphicFramePr>
        <p:xfrm>
          <a:off x="3263423" y="2209800"/>
          <a:ext cx="5911215" cy="2438400"/>
        </p:xfrm>
        <a:graphic>
          <a:graphicData uri="http://schemas.openxmlformats.org/drawingml/2006/table">
            <a:tbl>
              <a:tblPr/>
              <a:tblGrid>
                <a:gridCol w="1103630">
                  <a:extLst>
                    <a:ext uri="{9D8B030D-6E8A-4147-A177-3AD203B41FA5}">
                      <a16:colId xmlns:a16="http://schemas.microsoft.com/office/drawing/2014/main" val="649213708"/>
                    </a:ext>
                  </a:extLst>
                </a:gridCol>
                <a:gridCol w="2057718">
                  <a:extLst>
                    <a:ext uri="{9D8B030D-6E8A-4147-A177-3AD203B41FA5}">
                      <a16:colId xmlns:a16="http://schemas.microsoft.com/office/drawing/2014/main" val="2970294947"/>
                    </a:ext>
                  </a:extLst>
                </a:gridCol>
                <a:gridCol w="2749867">
                  <a:extLst>
                    <a:ext uri="{9D8B030D-6E8A-4147-A177-3AD203B41FA5}">
                      <a16:colId xmlns:a16="http://schemas.microsoft.com/office/drawing/2014/main" val="405178043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t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 of moisture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inc supplementation (mg/kg)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09381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le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7116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(Zn</a:t>
                      </a:r>
                      <a:r>
                        <a:rPr lang="en-GB" sz="1400" b="0" i="0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7330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baseline="-25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35693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715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(Zn</a:t>
                      </a:r>
                      <a:r>
                        <a:rPr lang="en-GB" sz="1400" b="0" i="0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h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39753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h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5469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h-fermented spinach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10766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290B7F0-F1CD-AEF6-CCDC-23EB92D67266}"/>
              </a:ext>
            </a:extLst>
          </p:cNvPr>
          <p:cNvSpPr txBox="1"/>
          <p:nvPr/>
        </p:nvSpPr>
        <p:spPr>
          <a:xfrm>
            <a:off x="-1" y="4800600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le S1 – 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mmary of the diets formulated for the feeding trial, including the respective source of moisture and zinc concentration, in addition to the standard wheat bran mixture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65311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B520BA9-9B96-9BAC-34C5-82DD2A8AE1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8E36BC8-4F06-4CA3-EF2A-48B56FA93432}"/>
              </a:ext>
            </a:extLst>
          </p:cNvPr>
          <p:cNvSpPr txBox="1"/>
          <p:nvPr/>
        </p:nvSpPr>
        <p:spPr>
          <a:xfrm>
            <a:off x="0" y="6199209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5 – Effect plots of protein content of all formulated diets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g/100g DM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6,1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32.231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white background with black lines&#10;&#10;AI-generated content may be incorrect.">
            <a:extLst>
              <a:ext uri="{FF2B5EF4-FFF2-40B4-BE49-F238E27FC236}">
                <a16:creationId xmlns:a16="http://schemas.microsoft.com/office/drawing/2014/main" id="{4F93FE84-E582-23AA-5154-8857F9DAA7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131" y="672295"/>
            <a:ext cx="10665738" cy="55134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41219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7FE382-941A-2C8D-974C-4664F29C5B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1244F0A-87A6-DA0D-8398-2C9DE1C514E7}"/>
              </a:ext>
            </a:extLst>
          </p:cNvPr>
          <p:cNvSpPr txBox="1"/>
          <p:nvPr/>
        </p:nvSpPr>
        <p:spPr>
          <a:xfrm>
            <a:off x="-24224" y="5996226"/>
            <a:ext cx="122162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6 –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plots of o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ganic acids content in spinach samples: Citric Acid (F</a:t>
            </a:r>
            <a:r>
              <a:rPr lang="en-GB" sz="1600" i="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,7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24.7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002),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ic Acid (F</a:t>
            </a:r>
            <a:r>
              <a:rPr lang="en-GB" sz="16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,7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50.9, </a:t>
            </a:r>
            <a:r>
              <a:rPr lang="en-GB" sz="1600" i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evulinic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cid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7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890.5; </a:t>
            </a:r>
            <a:r>
              <a:rPr lang="en-GB" sz="1600" i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lic Acid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7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25.765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xalic Acid (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,7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1.173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386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Phytic Acid (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7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.935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0245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9CF9CDFD-8691-B4E3-5EA9-1B22E03DF851}"/>
              </a:ext>
            </a:extLst>
          </p:cNvPr>
          <p:cNvGrpSpPr/>
          <p:nvPr/>
        </p:nvGrpSpPr>
        <p:grpSpPr>
          <a:xfrm>
            <a:off x="0" y="-1"/>
            <a:ext cx="12192000" cy="6074475"/>
            <a:chOff x="0" y="-1"/>
            <a:chExt cx="12192000" cy="6074475"/>
          </a:xfrm>
        </p:grpSpPr>
        <p:pic>
          <p:nvPicPr>
            <p:cNvPr id="4" name="Picture 3" descr="A chart of a number of objects&#10;&#10;AI-generated content may be incorrect.">
              <a:extLst>
                <a:ext uri="{FF2B5EF4-FFF2-40B4-BE49-F238E27FC236}">
                  <a16:creationId xmlns:a16="http://schemas.microsoft.com/office/drawing/2014/main" id="{BA18385E-5555-B7A8-1617-64B5FB98619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4088923" cy="2838023"/>
            </a:xfrm>
            <a:prstGeom prst="rect">
              <a:avLst/>
            </a:prstGeom>
          </p:spPr>
        </p:pic>
        <p:pic>
          <p:nvPicPr>
            <p:cNvPr id="8" name="Picture 7" descr="A graph of a number of cells&#10;&#10;AI-generated content may be incorrect.">
              <a:extLst>
                <a:ext uri="{FF2B5EF4-FFF2-40B4-BE49-F238E27FC236}">
                  <a16:creationId xmlns:a16="http://schemas.microsoft.com/office/drawing/2014/main" id="{BF50EBC2-C9A2-7D82-0DD8-ADBA547C8C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03077" y="-1"/>
              <a:ext cx="4088923" cy="2838023"/>
            </a:xfrm>
            <a:prstGeom prst="rect">
              <a:avLst/>
            </a:prstGeom>
          </p:spPr>
        </p:pic>
        <p:pic>
          <p:nvPicPr>
            <p:cNvPr id="16" name="Picture 15" descr="A chart with lines and dots&#10;&#10;AI-generated content may be incorrect.">
              <a:extLst>
                <a:ext uri="{FF2B5EF4-FFF2-40B4-BE49-F238E27FC236}">
                  <a16:creationId xmlns:a16="http://schemas.microsoft.com/office/drawing/2014/main" id="{1E509AE5-A1FB-5B9C-2FF3-CFFFD46364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11672" y="0"/>
              <a:ext cx="4088923" cy="2838023"/>
            </a:xfrm>
            <a:prstGeom prst="rect">
              <a:avLst/>
            </a:prstGeom>
          </p:spPr>
        </p:pic>
        <p:pic>
          <p:nvPicPr>
            <p:cNvPr id="18" name="Picture 17" descr="A graph of a number of different substances&#10;&#10;AI-generated content may be incorrect.">
              <a:extLst>
                <a:ext uri="{FF2B5EF4-FFF2-40B4-BE49-F238E27FC236}">
                  <a16:creationId xmlns:a16="http://schemas.microsoft.com/office/drawing/2014/main" id="{7AB207EF-0920-FE58-E8F7-CB8186496BE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34795"/>
              <a:ext cx="4088924" cy="2838024"/>
            </a:xfrm>
            <a:prstGeom prst="rect">
              <a:avLst/>
            </a:prstGeom>
          </p:spPr>
        </p:pic>
        <p:pic>
          <p:nvPicPr>
            <p:cNvPr id="20" name="Picture 19" descr="A graph of a number of oxalic acid&#10;&#10;AI-generated content may be incorrect.">
              <a:extLst>
                <a:ext uri="{FF2B5EF4-FFF2-40B4-BE49-F238E27FC236}">
                  <a16:creationId xmlns:a16="http://schemas.microsoft.com/office/drawing/2014/main" id="{13FBB695-4F3D-D99F-8E50-06B5CC430BC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8923" y="3234795"/>
              <a:ext cx="4091309" cy="2839679"/>
            </a:xfrm>
            <a:prstGeom prst="rect">
              <a:avLst/>
            </a:prstGeom>
          </p:spPr>
        </p:pic>
        <p:pic>
          <p:nvPicPr>
            <p:cNvPr id="22" name="Picture 21" descr="A graph of a phytic acid&#10;&#10;AI-generated content may be incorrect.">
              <a:extLst>
                <a:ext uri="{FF2B5EF4-FFF2-40B4-BE49-F238E27FC236}">
                  <a16:creationId xmlns:a16="http://schemas.microsoft.com/office/drawing/2014/main" id="{D8631AAC-9464-DE07-D1AC-5440B744C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00690" y="3234795"/>
              <a:ext cx="4091309" cy="283967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189268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92BD87-6B21-AFB5-C4DB-70B10E0310F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689A0A6-E589-59B3-36A8-E9ADD5F01CED}"/>
              </a:ext>
            </a:extLst>
          </p:cNvPr>
          <p:cNvSpPr txBox="1"/>
          <p:nvPr/>
        </p:nvSpPr>
        <p:spPr>
          <a:xfrm>
            <a:off x="0" y="5846028"/>
            <a:ext cx="1219200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7 –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ffect plot of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ree amino nitrogen in spinach samples (FAN; g/100g DM;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4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86.3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with numbers and lines&#10;&#10;AI-generated content may be incorrect.">
            <a:extLst>
              <a:ext uri="{FF2B5EF4-FFF2-40B4-BE49-F238E27FC236}">
                <a16:creationId xmlns:a16="http://schemas.microsoft.com/office/drawing/2014/main" id="{29A8CE77-C49D-BDFA-BA99-81D4CA3F61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4856" y="527821"/>
            <a:ext cx="7662283" cy="5318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94790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65C8FE-BD23-7D98-F9CF-D3EEB78BC0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3DD8605-CED9-23DE-60C7-0C8DD13A4E1E}"/>
              </a:ext>
            </a:extLst>
          </p:cNvPr>
          <p:cNvSpPr txBox="1"/>
          <p:nvPr/>
        </p:nvSpPr>
        <p:spPr>
          <a:xfrm>
            <a:off x="-13784" y="5579065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8 – Effect plots for the following free amino acids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mg/100g DM) in spinach sample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lani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9.393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277), Argini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266.72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spartic Acid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219.78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lutamic Acid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9.26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0284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lyc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4.9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0123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Histidi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369.43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9A7DA71F-6A23-4246-7160-51C3F6616030}"/>
              </a:ext>
            </a:extLst>
          </p:cNvPr>
          <p:cNvGrpSpPr/>
          <p:nvPr/>
        </p:nvGrpSpPr>
        <p:grpSpPr>
          <a:xfrm>
            <a:off x="-1" y="0"/>
            <a:ext cx="12192001" cy="5431542"/>
            <a:chOff x="-1" y="0"/>
            <a:chExt cx="12192001" cy="5431542"/>
          </a:xfrm>
        </p:grpSpPr>
        <p:pic>
          <p:nvPicPr>
            <p:cNvPr id="4" name="Picture 3" descr="A graph of a number of numbers&#10;&#10;AI-generated content may be incorrect.">
              <a:extLst>
                <a:ext uri="{FF2B5EF4-FFF2-40B4-BE49-F238E27FC236}">
                  <a16:creationId xmlns:a16="http://schemas.microsoft.com/office/drawing/2014/main" id="{458926CB-A342-D297-DEFE-970726FB9D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"/>
              <a:ext cx="4200299" cy="2715771"/>
            </a:xfrm>
            <a:prstGeom prst="rect">
              <a:avLst/>
            </a:prstGeom>
          </p:spPr>
        </p:pic>
        <p:pic>
          <p:nvPicPr>
            <p:cNvPr id="9" name="Picture 8" descr="A graph of a number of data&#10;&#10;AI-generated content may be incorrect.">
              <a:extLst>
                <a:ext uri="{FF2B5EF4-FFF2-40B4-BE49-F238E27FC236}">
                  <a16:creationId xmlns:a16="http://schemas.microsoft.com/office/drawing/2014/main" id="{E7DF7E4A-1130-3D7E-A7D9-5131539F95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5850" y="0"/>
              <a:ext cx="4200299" cy="2715771"/>
            </a:xfrm>
            <a:prstGeom prst="rect">
              <a:avLst/>
            </a:prstGeom>
          </p:spPr>
        </p:pic>
        <p:pic>
          <p:nvPicPr>
            <p:cNvPr id="6" name="Picture 5" descr="A graph of a number of different types of acid&#10;&#10;AI-generated content may be incorrect.">
              <a:extLst>
                <a:ext uri="{FF2B5EF4-FFF2-40B4-BE49-F238E27FC236}">
                  <a16:creationId xmlns:a16="http://schemas.microsoft.com/office/drawing/2014/main" id="{AC952F83-C051-F4C7-99F1-B4178DF662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91701" y="1"/>
              <a:ext cx="4200299" cy="2715771"/>
            </a:xfrm>
            <a:prstGeom prst="rect">
              <a:avLst/>
            </a:prstGeom>
          </p:spPr>
        </p:pic>
        <p:pic>
          <p:nvPicPr>
            <p:cNvPr id="11" name="Picture 10" descr="A graph of glutamic acid&#10;&#10;AI-generated content may be incorrect.">
              <a:extLst>
                <a:ext uri="{FF2B5EF4-FFF2-40B4-BE49-F238E27FC236}">
                  <a16:creationId xmlns:a16="http://schemas.microsoft.com/office/drawing/2014/main" id="{1E212925-328B-8D1C-6666-373D76373B5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" y="2715771"/>
              <a:ext cx="4200299" cy="2715771"/>
            </a:xfrm>
            <a:prstGeom prst="rect">
              <a:avLst/>
            </a:prstGeom>
          </p:spPr>
        </p:pic>
        <p:pic>
          <p:nvPicPr>
            <p:cNvPr id="14" name="Picture 13" descr="A graph of a number of glycines&#10;&#10;AI-generated content may be incorrect.">
              <a:extLst>
                <a:ext uri="{FF2B5EF4-FFF2-40B4-BE49-F238E27FC236}">
                  <a16:creationId xmlns:a16="http://schemas.microsoft.com/office/drawing/2014/main" id="{3141BCF0-EDDB-817D-A27D-61A91ED3B78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5850" y="2715771"/>
              <a:ext cx="4200299" cy="2715771"/>
            </a:xfrm>
            <a:prstGeom prst="rect">
              <a:avLst/>
            </a:prstGeom>
          </p:spPr>
        </p:pic>
        <p:pic>
          <p:nvPicPr>
            <p:cNvPr id="17" name="Picture 16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DD994741-DF40-2979-B2A6-AE057325359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91701" y="2715771"/>
              <a:ext cx="4200299" cy="271577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5218355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4D8FEA-49F0-685A-CD0F-0A5D352C7FD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B566CAF-8417-1F9A-00A4-68C5C0D879BC}"/>
              </a:ext>
            </a:extLst>
          </p:cNvPr>
          <p:cNvSpPr txBox="1"/>
          <p:nvPr/>
        </p:nvSpPr>
        <p:spPr>
          <a:xfrm>
            <a:off x="-13784" y="5579065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9 –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plots for the following free amino acids (mg/100 g DM) in spinach sample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Isoleuc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3.42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148), Leuc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1.27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202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ys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26.09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044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thionine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220.06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enylalan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1.12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0207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Proli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05.26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8FC78A9-D5BA-8D65-936C-1D345E7F44E1}"/>
              </a:ext>
            </a:extLst>
          </p:cNvPr>
          <p:cNvGrpSpPr/>
          <p:nvPr/>
        </p:nvGrpSpPr>
        <p:grpSpPr>
          <a:xfrm>
            <a:off x="0" y="-5062"/>
            <a:ext cx="12192000" cy="5595260"/>
            <a:chOff x="0" y="-5062"/>
            <a:chExt cx="12192000" cy="5595260"/>
          </a:xfrm>
        </p:grpSpPr>
        <p:pic>
          <p:nvPicPr>
            <p:cNvPr id="5" name="Picture 4" descr="A graph of a number of objects&#10;&#10;AI-generated content may be incorrect.">
              <a:extLst>
                <a:ext uri="{FF2B5EF4-FFF2-40B4-BE49-F238E27FC236}">
                  <a16:creationId xmlns:a16="http://schemas.microsoft.com/office/drawing/2014/main" id="{BAE2B5D5-FD61-CF4D-E8EA-AB88073B5D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562"/>
              <a:ext cx="4176381" cy="2700306"/>
            </a:xfrm>
            <a:prstGeom prst="rect">
              <a:avLst/>
            </a:prstGeom>
          </p:spPr>
        </p:pic>
        <p:pic>
          <p:nvPicPr>
            <p:cNvPr id="12" name="Picture 11" descr="A graph of a number of people&#10;&#10;AI-generated content may be incorrect.">
              <a:extLst>
                <a:ext uri="{FF2B5EF4-FFF2-40B4-BE49-F238E27FC236}">
                  <a16:creationId xmlns:a16="http://schemas.microsoft.com/office/drawing/2014/main" id="{5A2D5CCE-5EB5-1F1D-CDD2-04F63BC9F1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4908" y="0"/>
              <a:ext cx="4194469" cy="2712001"/>
            </a:xfrm>
            <a:prstGeom prst="rect">
              <a:avLst/>
            </a:prstGeom>
          </p:spPr>
        </p:pic>
        <p:pic>
          <p:nvPicPr>
            <p:cNvPr id="8" name="Picture 7" descr="A graph of a number of data&#10;&#10;AI-generated content may be incorrect.">
              <a:extLst>
                <a:ext uri="{FF2B5EF4-FFF2-40B4-BE49-F238E27FC236}">
                  <a16:creationId xmlns:a16="http://schemas.microsoft.com/office/drawing/2014/main" id="{859808A7-6AD4-8194-C9A6-0D35A5FC449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15619" y="-5062"/>
              <a:ext cx="4176381" cy="2700306"/>
            </a:xfrm>
            <a:prstGeom prst="rect">
              <a:avLst/>
            </a:prstGeom>
          </p:spPr>
        </p:pic>
        <p:pic>
          <p:nvPicPr>
            <p:cNvPr id="15" name="Picture 14" descr="A graph of methionine&#10;&#10;AI-generated content may be incorrect.">
              <a:extLst>
                <a:ext uri="{FF2B5EF4-FFF2-40B4-BE49-F238E27FC236}">
                  <a16:creationId xmlns:a16="http://schemas.microsoft.com/office/drawing/2014/main" id="{F5C7A87B-B952-8DDE-20BF-9FA741CA8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881514"/>
              <a:ext cx="4176379" cy="2700305"/>
            </a:xfrm>
            <a:prstGeom prst="rect">
              <a:avLst/>
            </a:prstGeom>
          </p:spPr>
        </p:pic>
        <p:pic>
          <p:nvPicPr>
            <p:cNvPr id="18" name="Picture 17" descr="A graph of a number of numbers&#10;&#10;AI-generated content may be incorrect.">
              <a:extLst>
                <a:ext uri="{FF2B5EF4-FFF2-40B4-BE49-F238E27FC236}">
                  <a16:creationId xmlns:a16="http://schemas.microsoft.com/office/drawing/2014/main" id="{13B03CCB-10D7-EE35-8DC5-B186AC237C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07811" y="2884268"/>
              <a:ext cx="4176379" cy="2700305"/>
            </a:xfrm>
            <a:prstGeom prst="rect">
              <a:avLst/>
            </a:prstGeom>
          </p:spPr>
        </p:pic>
        <p:pic>
          <p:nvPicPr>
            <p:cNvPr id="21" name="Picture 20" descr="A graph of a number of proline&#10;&#10;AI-generated content may be incorrect.">
              <a:extLst>
                <a:ext uri="{FF2B5EF4-FFF2-40B4-BE49-F238E27FC236}">
                  <a16:creationId xmlns:a16="http://schemas.microsoft.com/office/drawing/2014/main" id="{BB43A17F-84DA-8090-A4EB-CBB2CF1CB7C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15620" y="2889892"/>
              <a:ext cx="4176380" cy="270030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709926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B06896-B835-35DE-16CA-9627165636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631B885-795A-793A-9115-99C6A6D0E568}"/>
              </a:ext>
            </a:extLst>
          </p:cNvPr>
          <p:cNvSpPr txBox="1"/>
          <p:nvPr/>
        </p:nvSpPr>
        <p:spPr>
          <a:xfrm>
            <a:off x="-13784" y="5579065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0 –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plots for the following free amino acids (mg/100 g DM) in spinach sample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Seri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98.003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reon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0.39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233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ryptophan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418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ros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88.18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0.0004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Valin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4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1.59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193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E114497-5C2D-1ED6-E04E-559AC02AF295}"/>
              </a:ext>
            </a:extLst>
          </p:cNvPr>
          <p:cNvGrpSpPr/>
          <p:nvPr/>
        </p:nvGrpSpPr>
        <p:grpSpPr>
          <a:xfrm>
            <a:off x="3150" y="0"/>
            <a:ext cx="12188850" cy="5582246"/>
            <a:chOff x="3150" y="0"/>
            <a:chExt cx="12188850" cy="5582246"/>
          </a:xfrm>
        </p:grpSpPr>
        <p:pic>
          <p:nvPicPr>
            <p:cNvPr id="4" name="Picture 3" descr="A graph of a number of objects&#10;&#10;AI-generated content may be incorrect.">
              <a:extLst>
                <a:ext uri="{FF2B5EF4-FFF2-40B4-BE49-F238E27FC236}">
                  <a16:creationId xmlns:a16="http://schemas.microsoft.com/office/drawing/2014/main" id="{A47709EC-D6BD-6DA4-A894-575B6C0443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0" y="3180"/>
              <a:ext cx="4133045" cy="2672287"/>
            </a:xfrm>
            <a:prstGeom prst="rect">
              <a:avLst/>
            </a:prstGeom>
          </p:spPr>
        </p:pic>
        <p:pic>
          <p:nvPicPr>
            <p:cNvPr id="7" name="Picture 6" descr="A graph with numbers and symbols&#10;&#10;AI-generated content may be incorrect.">
              <a:extLst>
                <a:ext uri="{FF2B5EF4-FFF2-40B4-BE49-F238E27FC236}">
                  <a16:creationId xmlns:a16="http://schemas.microsoft.com/office/drawing/2014/main" id="{795FB9C3-F5CE-18B2-2505-8824E7A172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5807" y="3181"/>
              <a:ext cx="4136193" cy="2674322"/>
            </a:xfrm>
            <a:prstGeom prst="rect">
              <a:avLst/>
            </a:prstGeom>
          </p:spPr>
        </p:pic>
        <p:pic>
          <p:nvPicPr>
            <p:cNvPr id="10" name="Picture 9" descr="A graph of a number of objects&#10;&#10;AI-generated content may be incorrect.">
              <a:extLst>
                <a:ext uri="{FF2B5EF4-FFF2-40B4-BE49-F238E27FC236}">
                  <a16:creationId xmlns:a16="http://schemas.microsoft.com/office/drawing/2014/main" id="{7BAEA6A3-3FF9-CEB6-EC9E-4ABB650F1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14119" y="0"/>
              <a:ext cx="4136193" cy="2674322"/>
            </a:xfrm>
            <a:prstGeom prst="rect">
              <a:avLst/>
            </a:prstGeom>
          </p:spPr>
        </p:pic>
        <p:pic>
          <p:nvPicPr>
            <p:cNvPr id="13" name="Picture 12" descr="A graph of a number of tyrosine&#10;&#10;AI-generated content may be incorrect.">
              <a:extLst>
                <a:ext uri="{FF2B5EF4-FFF2-40B4-BE49-F238E27FC236}">
                  <a16:creationId xmlns:a16="http://schemas.microsoft.com/office/drawing/2014/main" id="{4D6E3C12-04D6-EF82-C381-D38BE34D79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9808" y="2901562"/>
              <a:ext cx="4136192" cy="2674322"/>
            </a:xfrm>
            <a:prstGeom prst="rect">
              <a:avLst/>
            </a:prstGeom>
          </p:spPr>
        </p:pic>
        <p:pic>
          <p:nvPicPr>
            <p:cNvPr id="16" name="Picture 15" descr="A graph of a number of data&#10;&#10;AI-generated content may be incorrect.">
              <a:extLst>
                <a:ext uri="{FF2B5EF4-FFF2-40B4-BE49-F238E27FC236}">
                  <a16:creationId xmlns:a16="http://schemas.microsoft.com/office/drawing/2014/main" id="{6DFEB967-5E9D-07B0-B917-89E05CC7EC9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45092" y="2907924"/>
              <a:ext cx="4136192" cy="267432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2457807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3844FD-3091-A35B-CC3C-5777AD9866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711C15E-DFA1-5FD5-0E5F-612452D86144}"/>
              </a:ext>
            </a:extLst>
          </p:cNvPr>
          <p:cNvSpPr txBox="1"/>
          <p:nvPr/>
        </p:nvSpPr>
        <p:spPr>
          <a:xfrm>
            <a:off x="-13784" y="5579065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1 –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plots for the following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olatile compounds (AU)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spinach sample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2-Butanon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631.13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2-Ethylfuran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372.63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2-Methylbutanal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478.7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3-Methylbutanal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6.605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0148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3-Methyl-1-butanol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3066.6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55C57E2-2BD1-B078-A0FA-D6CE91A16609}"/>
              </a:ext>
            </a:extLst>
          </p:cNvPr>
          <p:cNvGrpSpPr/>
          <p:nvPr/>
        </p:nvGrpSpPr>
        <p:grpSpPr>
          <a:xfrm>
            <a:off x="1" y="-3"/>
            <a:ext cx="12178214" cy="5580883"/>
            <a:chOff x="1" y="-3"/>
            <a:chExt cx="12178214" cy="5580883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D1D395F5-FC83-9C0D-CC14-BDC44BB491E2}"/>
                </a:ext>
              </a:extLst>
            </p:cNvPr>
            <p:cNvGrpSpPr/>
            <p:nvPr/>
          </p:nvGrpSpPr>
          <p:grpSpPr>
            <a:xfrm>
              <a:off x="1" y="-3"/>
              <a:ext cx="12178214" cy="5579060"/>
              <a:chOff x="1" y="-3"/>
              <a:chExt cx="12178214" cy="5579060"/>
            </a:xfrm>
          </p:grpSpPr>
          <p:pic>
            <p:nvPicPr>
              <p:cNvPr id="6" name="Picture 5" descr="A graph of a number of data&#10;&#10;AI-generated content may be incorrect.">
                <a:extLst>
                  <a:ext uri="{FF2B5EF4-FFF2-40B4-BE49-F238E27FC236}">
                    <a16:creationId xmlns:a16="http://schemas.microsoft.com/office/drawing/2014/main" id="{E64AD18E-24E1-F15D-2EB8-A3E7336D65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" y="-3"/>
                <a:ext cx="4219574" cy="2728233"/>
              </a:xfrm>
              <a:prstGeom prst="rect">
                <a:avLst/>
              </a:prstGeom>
            </p:spPr>
          </p:pic>
          <p:pic>
            <p:nvPicPr>
              <p:cNvPr id="11" name="Picture 10" descr="A graph of a number of objects&#10;&#10;AI-generated content may be incorrect.">
                <a:extLst>
                  <a:ext uri="{FF2B5EF4-FFF2-40B4-BE49-F238E27FC236}">
                    <a16:creationId xmlns:a16="http://schemas.microsoft.com/office/drawing/2014/main" id="{CFA99904-12DA-D451-874E-1B6B28B53E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86211" y="0"/>
                <a:ext cx="4219575" cy="2728234"/>
              </a:xfrm>
              <a:prstGeom prst="rect">
                <a:avLst/>
              </a:prstGeom>
            </p:spPr>
          </p:pic>
          <p:pic>
            <p:nvPicPr>
              <p:cNvPr id="9" name="Picture 8" descr="A graph of a number of numbers&#10;&#10;AI-generated content may be incorrect.">
                <a:extLst>
                  <a:ext uri="{FF2B5EF4-FFF2-40B4-BE49-F238E27FC236}">
                    <a16:creationId xmlns:a16="http://schemas.microsoft.com/office/drawing/2014/main" id="{282507F3-DD3E-4ED0-B7A3-82454D1AD0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58640" y="-2"/>
                <a:ext cx="4219575" cy="2728234"/>
              </a:xfrm>
              <a:prstGeom prst="rect">
                <a:avLst/>
              </a:prstGeom>
            </p:spPr>
          </p:pic>
          <p:pic>
            <p:nvPicPr>
              <p:cNvPr id="13" name="Picture 12" descr="A graph of a number of numbers&#10;&#10;AI-generated content may be incorrect.">
                <a:extLst>
                  <a:ext uri="{FF2B5EF4-FFF2-40B4-BE49-F238E27FC236}">
                    <a16:creationId xmlns:a16="http://schemas.microsoft.com/office/drawing/2014/main" id="{50BD56F3-6F17-32BC-DD36-6223B19F67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76423" y="2850823"/>
                <a:ext cx="4219575" cy="2728234"/>
              </a:xfrm>
              <a:prstGeom prst="rect">
                <a:avLst/>
              </a:prstGeom>
            </p:spPr>
          </p:pic>
        </p:grpSp>
        <p:pic>
          <p:nvPicPr>
            <p:cNvPr id="7" name="Picture 6" descr="A graph of a number of different types of substances&#10;&#10;AI-generated content may be incorrect.">
              <a:extLst>
                <a:ext uri="{FF2B5EF4-FFF2-40B4-BE49-F238E27FC236}">
                  <a16:creationId xmlns:a16="http://schemas.microsoft.com/office/drawing/2014/main" id="{3E70F46E-470B-FDB8-56F4-848CC4CA199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5998" y="2850823"/>
              <a:ext cx="4233361" cy="27300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1614869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643106-F09B-F24D-DC84-B700355638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48F9D8F-E4E6-50C2-8B1E-C57A2F02F8D4}"/>
              </a:ext>
            </a:extLst>
          </p:cNvPr>
          <p:cNvSpPr txBox="1"/>
          <p:nvPr/>
        </p:nvSpPr>
        <p:spPr>
          <a:xfrm>
            <a:off x="-14893" y="5863545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2 –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plots for the following volatile compounds (AU) in spinach sample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Benzaldehyde (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5.679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0.022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imethyl Disulfide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508.87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Ethyl Acetate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545.3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Hexanal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,8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13236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55A278F-EAA1-F7E1-A69B-CA164789B674}"/>
              </a:ext>
            </a:extLst>
          </p:cNvPr>
          <p:cNvGrpSpPr/>
          <p:nvPr/>
        </p:nvGrpSpPr>
        <p:grpSpPr>
          <a:xfrm>
            <a:off x="1784916" y="294924"/>
            <a:ext cx="8622168" cy="5568621"/>
            <a:chOff x="1784916" y="-2"/>
            <a:chExt cx="8622168" cy="5568621"/>
          </a:xfrm>
        </p:grpSpPr>
        <p:pic>
          <p:nvPicPr>
            <p:cNvPr id="4" name="Picture 3" descr="A graph of a number of objects&#10;&#10;AI-generated content may be incorrect.">
              <a:extLst>
                <a:ext uri="{FF2B5EF4-FFF2-40B4-BE49-F238E27FC236}">
                  <a16:creationId xmlns:a16="http://schemas.microsoft.com/office/drawing/2014/main" id="{B62A3655-19FD-DE6B-C797-E449DC4089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4476" y="-2"/>
              <a:ext cx="4296191" cy="2777771"/>
            </a:xfrm>
            <a:prstGeom prst="rect">
              <a:avLst/>
            </a:prstGeom>
          </p:spPr>
        </p:pic>
        <p:pic>
          <p:nvPicPr>
            <p:cNvPr id="9" name="Picture 8" descr="A graph of a number of objects&#10;&#10;AI-generated content may be incorrect.">
              <a:extLst>
                <a:ext uri="{FF2B5EF4-FFF2-40B4-BE49-F238E27FC236}">
                  <a16:creationId xmlns:a16="http://schemas.microsoft.com/office/drawing/2014/main" id="{8A18C195-8309-09A4-3764-1EDC78226A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4916" y="2777769"/>
              <a:ext cx="4316419" cy="2790850"/>
            </a:xfrm>
            <a:prstGeom prst="rect">
              <a:avLst/>
            </a:prstGeom>
          </p:spPr>
        </p:pic>
        <p:pic>
          <p:nvPicPr>
            <p:cNvPr id="12" name="Picture 11" descr="A graph of a number of numbers&#10;&#10;AI-generated content may be incorrect.">
              <a:extLst>
                <a:ext uri="{FF2B5EF4-FFF2-40B4-BE49-F238E27FC236}">
                  <a16:creationId xmlns:a16="http://schemas.microsoft.com/office/drawing/2014/main" id="{961CC7A8-08D4-2364-6C80-1F2F5CE1D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81107" y="2777769"/>
              <a:ext cx="4316417" cy="2790849"/>
            </a:xfrm>
            <a:prstGeom prst="rect">
              <a:avLst/>
            </a:prstGeom>
          </p:spPr>
        </p:pic>
        <p:pic>
          <p:nvPicPr>
            <p:cNvPr id="5" name="Picture 4" descr="A graph of a number of different numbers&#10;&#10;AI-generated content may be incorrect.">
              <a:extLst>
                <a:ext uri="{FF2B5EF4-FFF2-40B4-BE49-F238E27FC236}">
                  <a16:creationId xmlns:a16="http://schemas.microsoft.com/office/drawing/2014/main" id="{CBBE8D8A-0FF6-4069-3DEE-A7B301229E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0667" y="0"/>
              <a:ext cx="4316417" cy="27836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3470058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DEED570-44B9-F6AE-F551-1981D9F3702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FE000EC-65E6-5A53-30A0-4117AAF8D275}"/>
              </a:ext>
            </a:extLst>
          </p:cNvPr>
          <p:cNvSpPr txBox="1"/>
          <p:nvPr/>
        </p:nvSpPr>
        <p:spPr>
          <a:xfrm>
            <a:off x="0" y="5380672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3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displaying the coefficients (dots) with 95CIs (vertical bars with whiskers) analysing the weight of the larvae (in mg), according to the concentration of zinc in the diet (Zn</a:t>
            </a:r>
            <a:r>
              <a:rPr lang="en-GB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</a:t>
            </a:r>
            <a:r>
              <a:rPr lang="en-GB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</a:t>
            </a:r>
            <a:r>
              <a:rPr lang="en-GB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eft) and the fermentation status of the spinach in the diet (fermented for 96 hours or not, right) as simple effects, including experimental block as a random factor.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C9C25C1-BDA3-61BF-B629-A1D42CD52741}"/>
              </a:ext>
            </a:extLst>
          </p:cNvPr>
          <p:cNvGrpSpPr/>
          <p:nvPr/>
        </p:nvGrpSpPr>
        <p:grpSpPr>
          <a:xfrm>
            <a:off x="3714750" y="730768"/>
            <a:ext cx="4762500" cy="4572000"/>
            <a:chOff x="3714750" y="730768"/>
            <a:chExt cx="4762500" cy="4572000"/>
          </a:xfrm>
        </p:grpSpPr>
        <p:pic>
          <p:nvPicPr>
            <p:cNvPr id="4" name="Picture 3" descr="A chart with numbers and lines&#10;&#10;AI-generated content may be incorrect.">
              <a:extLst>
                <a:ext uri="{FF2B5EF4-FFF2-40B4-BE49-F238E27FC236}">
                  <a16:creationId xmlns:a16="http://schemas.microsoft.com/office/drawing/2014/main" id="{1D101B8F-719C-A172-F6EE-A0C3CFE772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4750" y="730768"/>
              <a:ext cx="2381250" cy="4572000"/>
            </a:xfrm>
            <a:prstGeom prst="rect">
              <a:avLst/>
            </a:prstGeom>
          </p:spPr>
        </p:pic>
        <p:pic>
          <p:nvPicPr>
            <p:cNvPr id="7" name="Picture 6" descr="A graph with numbers and lines&#10;&#10;AI-generated content may be incorrect.">
              <a:extLst>
                <a:ext uri="{FF2B5EF4-FFF2-40B4-BE49-F238E27FC236}">
                  <a16:creationId xmlns:a16="http://schemas.microsoft.com/office/drawing/2014/main" id="{B4F6F00E-9E7D-5953-0CBD-9809017B3C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730768"/>
              <a:ext cx="2381250" cy="457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306451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13AE32-D9D1-5779-FA12-E14275873F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EE95B0A-F4E9-2BE9-B141-C42B7C01C0FF}"/>
              </a:ext>
            </a:extLst>
          </p:cNvPr>
          <p:cNvSpPr txBox="1"/>
          <p:nvPr/>
        </p:nvSpPr>
        <p:spPr>
          <a:xfrm>
            <a:off x="0" y="6199209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4 – Effect plots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the estimation of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zinc content (mg/kg) in all formulated diets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6,1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</a:t>
            </a:r>
            <a:r>
              <a:rPr lang="en-GB" sz="1600" kern="0" dirty="0">
                <a:solidFill>
                  <a:srgbClr val="C5C8C6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21.23,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.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with a white background&#10;&#10;AI-generated content may be incorrect.">
            <a:extLst>
              <a:ext uri="{FF2B5EF4-FFF2-40B4-BE49-F238E27FC236}">
                <a16:creationId xmlns:a16="http://schemas.microsoft.com/office/drawing/2014/main" id="{15770143-B499-3AB0-BBFB-0F2ADE38B3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123" y="625828"/>
            <a:ext cx="10781754" cy="5573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180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AAA81CB-F1CD-1161-BD4B-78E312B00678}"/>
              </a:ext>
            </a:extLst>
          </p:cNvPr>
          <p:cNvSpPr txBox="1"/>
          <p:nvPr/>
        </p:nvSpPr>
        <p:spPr>
          <a:xfrm>
            <a:off x="3149329" y="5311140"/>
            <a:ext cx="5893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le S2 – </a:t>
            </a:r>
            <a:r>
              <a:rPr lang="en-GB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conditions for ICP-MS measurement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7BA74CA-B65F-8217-22E5-28A9C4D698E8}"/>
              </a:ext>
            </a:extLst>
          </p:cNvPr>
          <p:cNvGraphicFramePr>
            <a:graphicFrameLocks noGrp="1"/>
          </p:cNvGraphicFramePr>
          <p:nvPr/>
        </p:nvGraphicFramePr>
        <p:xfrm>
          <a:off x="3131152" y="2057400"/>
          <a:ext cx="5929694" cy="2743200"/>
        </p:xfrm>
        <a:graphic>
          <a:graphicData uri="http://schemas.openxmlformats.org/drawingml/2006/table">
            <a:tbl>
              <a:tblPr/>
              <a:tblGrid>
                <a:gridCol w="3343593">
                  <a:extLst>
                    <a:ext uri="{9D8B030D-6E8A-4147-A177-3AD203B41FA5}">
                      <a16:colId xmlns:a16="http://schemas.microsoft.com/office/drawing/2014/main" val="649213708"/>
                    </a:ext>
                  </a:extLst>
                </a:gridCol>
                <a:gridCol w="2586101">
                  <a:extLst>
                    <a:ext uri="{9D8B030D-6E8A-4147-A177-3AD203B41FA5}">
                      <a16:colId xmlns:a16="http://schemas.microsoft.com/office/drawing/2014/main" val="297029494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ower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0 W</a:t>
                      </a:r>
                      <a:endParaRPr lang="en-GB" sz="14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09381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l gas flow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L min</a:t>
                      </a:r>
                      <a:r>
                        <a:rPr lang="en-GB" sz="1400" b="0" i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en-GB" sz="1400" baseline="30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7116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xiliary gas flow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L min</a:t>
                      </a:r>
                      <a:r>
                        <a:rPr lang="en-GB" sz="1400" b="0" i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rgon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7330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bulizer gas flow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L min</a:t>
                      </a:r>
                      <a:r>
                        <a:rPr lang="en-GB" sz="1400" b="0" i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rgon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35693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bulizer type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Mist</a:t>
                      </a:r>
                      <a:endParaRPr lang="en-GB" sz="14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715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adrupole (m/z) </a:t>
                      </a:r>
                      <a:endParaRPr lang="en-GB" sz="1400" b="1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 (In), 103 (Rh), 66 (Zn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39753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e and rejection parameter q (</a:t>
                      </a:r>
                      <a:r>
                        <a:rPr lang="en-US" sz="14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q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n-NO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5469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it of quantitation Zn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µg L</a:t>
                      </a:r>
                      <a:r>
                        <a:rPr lang="en-GB" sz="1400" b="0" i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1076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4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ibration range 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–100 µg L</a:t>
                      </a:r>
                      <a:r>
                        <a:rPr lang="en-GB" sz="1400" b="0" i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07254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936424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48A718-5F74-3A9D-5C0E-1EED25C1EB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DF0551B-7BA2-D363-6E1C-536B7D177C7E}"/>
              </a:ext>
            </a:extLst>
          </p:cNvPr>
          <p:cNvSpPr txBox="1"/>
          <p:nvPr/>
        </p:nvSpPr>
        <p:spPr>
          <a:xfrm>
            <a:off x="1" y="5715000"/>
            <a:ext cx="121919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5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displaying the coefficients (dots) with 95% CIs (vertical bars with whiskers) analysing the log of the concentration of zinc (mg/kg) in the larvae according to the concentration of zinc in the diet they were fed (Zn</a:t>
            </a:r>
            <a:r>
              <a:rPr lang="en-GB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</a:t>
            </a:r>
            <a:r>
              <a:rPr lang="en-GB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</a:t>
            </a:r>
            <a:r>
              <a:rPr lang="en-GB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pic>
        <p:nvPicPr>
          <p:cNvPr id="5" name="Picture 4" descr="A graph of a patient's health&#10;&#10;AI-generated content may be incorrect.">
            <a:extLst>
              <a:ext uri="{FF2B5EF4-FFF2-40B4-BE49-F238E27FC236}">
                <a16:creationId xmlns:a16="http://schemas.microsoft.com/office/drawing/2014/main" id="{82E71FD8-2510-39BF-24E7-7FA93B6AA9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179894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FE558D-BADA-F9E7-4B6E-565D715D0F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8BE2F5A-A26A-CBFD-4D18-FEC233EB9AC1}"/>
              </a:ext>
            </a:extLst>
          </p:cNvPr>
          <p:cNvSpPr txBox="1"/>
          <p:nvPr/>
        </p:nvSpPr>
        <p:spPr>
          <a:xfrm>
            <a:off x="0" y="5992153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6 – Effect plot of the bioaccumulation factor (BAF) assessment of all formulated diets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d to mealworm in 35-day feeding trials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X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GB" sz="1600" baseline="-25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6,14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= 32.66,;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6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.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ts show mean predicted values with 95% confidence interval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a number of numbers&#10;&#10;AI-generated content may be incorrect.">
            <a:extLst>
              <a:ext uri="{FF2B5EF4-FFF2-40B4-BE49-F238E27FC236}">
                <a16:creationId xmlns:a16="http://schemas.microsoft.com/office/drawing/2014/main" id="{552C68DC-AD46-A2FF-D580-D15A6BF9B3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557" y="865846"/>
            <a:ext cx="9916886" cy="5126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79876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BE26E0-4C75-8C12-B568-EA5FBD50DE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27E361D-33B4-8835-6DB6-E2086A44D6BD}"/>
              </a:ext>
            </a:extLst>
          </p:cNvPr>
          <p:cNvSpPr txBox="1"/>
          <p:nvPr/>
        </p:nvSpPr>
        <p:spPr>
          <a:xfrm>
            <a:off x="0" y="4087166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7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ip charts representing the normalized counts of the 16S amplicons of the 5 genera detected as being differentially abundant between treatment groups (x-axis). Each panel contains the data relative to one single member of the genera stated above the plot window. Each dot represents the counts present in an individual larvae.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2E8CBCC9-2D2B-79F0-476A-A05E7BD36E48}"/>
              </a:ext>
            </a:extLst>
          </p:cNvPr>
          <p:cNvGrpSpPr/>
          <p:nvPr/>
        </p:nvGrpSpPr>
        <p:grpSpPr>
          <a:xfrm>
            <a:off x="0" y="240956"/>
            <a:ext cx="12065582" cy="3655710"/>
            <a:chOff x="62336" y="-1574"/>
            <a:chExt cx="12065582" cy="3655710"/>
          </a:xfrm>
        </p:grpSpPr>
        <p:pic>
          <p:nvPicPr>
            <p:cNvPr id="4" name="Picture 3" descr="A graph of a diet&#10;&#10;AI-generated content may be incorrect.">
              <a:extLst>
                <a:ext uri="{FF2B5EF4-FFF2-40B4-BE49-F238E27FC236}">
                  <a16:creationId xmlns:a16="http://schemas.microsoft.com/office/drawing/2014/main" id="{F4BB57DE-98EA-D493-1A39-79AAA4CFE5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36" y="-1574"/>
              <a:ext cx="4021282" cy="1827855"/>
            </a:xfrm>
            <a:prstGeom prst="rect">
              <a:avLst/>
            </a:prstGeom>
          </p:spPr>
        </p:pic>
        <p:pic>
          <p:nvPicPr>
            <p:cNvPr id="9" name="Picture 8" descr="A graph of a diet type&#10;&#10;AI-generated content may be incorrect.">
              <a:extLst>
                <a:ext uri="{FF2B5EF4-FFF2-40B4-BE49-F238E27FC236}">
                  <a16:creationId xmlns:a16="http://schemas.microsoft.com/office/drawing/2014/main" id="{4151097C-138A-1206-0CF1-F1E42462B67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5354" y="0"/>
              <a:ext cx="4021282" cy="1827855"/>
            </a:xfrm>
            <a:prstGeom prst="rect">
              <a:avLst/>
            </a:prstGeom>
          </p:spPr>
        </p:pic>
        <p:pic>
          <p:nvPicPr>
            <p:cNvPr id="11" name="Picture 10" descr="A graph of a diet type&#10;&#10;AI-generated content may be incorrect.">
              <a:extLst>
                <a:ext uri="{FF2B5EF4-FFF2-40B4-BE49-F238E27FC236}">
                  <a16:creationId xmlns:a16="http://schemas.microsoft.com/office/drawing/2014/main" id="{1FD08341-8F80-2C02-55FD-FCC0D1ED046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06636" y="-1"/>
              <a:ext cx="4021282" cy="1827855"/>
            </a:xfrm>
            <a:prstGeom prst="rect">
              <a:avLst/>
            </a:prstGeom>
          </p:spPr>
        </p:pic>
        <p:pic>
          <p:nvPicPr>
            <p:cNvPr id="13" name="Picture 12" descr="A graph of a diet type&#10;&#10;AI-generated content may be incorrect.">
              <a:extLst>
                <a:ext uri="{FF2B5EF4-FFF2-40B4-BE49-F238E27FC236}">
                  <a16:creationId xmlns:a16="http://schemas.microsoft.com/office/drawing/2014/main" id="{8D908301-CAC2-FD13-9D15-DFD4E8C5E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72977" y="1826281"/>
              <a:ext cx="4021282" cy="1827855"/>
            </a:xfrm>
            <a:prstGeom prst="rect">
              <a:avLst/>
            </a:prstGeom>
          </p:spPr>
        </p:pic>
        <p:pic>
          <p:nvPicPr>
            <p:cNvPr id="15" name="Picture 14" descr="A graph of a diet type&#10;&#10;AI-generated content may be incorrect.">
              <a:extLst>
                <a:ext uri="{FF2B5EF4-FFF2-40B4-BE49-F238E27FC236}">
                  <a16:creationId xmlns:a16="http://schemas.microsoft.com/office/drawing/2014/main" id="{6E4BDBB7-AC37-C5B3-B84A-8887A20A58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5995" y="1826281"/>
              <a:ext cx="4021282" cy="18278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5357988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F5004C-08B7-4243-5E13-DD451C84AD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00EC3D-A57F-BE43-3E5E-E900F0EC391D}"/>
              </a:ext>
            </a:extLst>
          </p:cNvPr>
          <p:cNvSpPr txBox="1"/>
          <p:nvPr/>
        </p:nvSpPr>
        <p:spPr>
          <a:xfrm>
            <a:off x="0" y="5657671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8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ip charts representing the Alpha diversity, expressed as the Shannon index, between larvae fed a control diet or diets containing spinach, either fresh or fermented for 96 hours, as well as 3 different concentrations of zinc. Each panel contains the index belonging to one treatment group. Each dot represents the Shannon index of one individual sample. </a:t>
            </a:r>
          </a:p>
        </p:txBody>
      </p:sp>
      <p:pic>
        <p:nvPicPr>
          <p:cNvPr id="4" name="Picture 3" descr="A group of black dots&#10;&#10;AI-generated content may be incorrect.">
            <a:extLst>
              <a:ext uri="{FF2B5EF4-FFF2-40B4-BE49-F238E27FC236}">
                <a16:creationId xmlns:a16="http://schemas.microsoft.com/office/drawing/2014/main" id="{D0629A86-348F-751D-BA02-B3E6DA32C3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93148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D74550-65D6-C6AF-EB1E-4710FB4055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5F16E42-6799-7C1F-CAC3-115F0101A6BA}"/>
              </a:ext>
            </a:extLst>
          </p:cNvPr>
          <p:cNvSpPr txBox="1"/>
          <p:nvPr/>
        </p:nvSpPr>
        <p:spPr>
          <a:xfrm>
            <a:off x="0" y="5657671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9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ordinates analysis (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 visualizing Bray-Curtis dissimilarity of the composition of the bacterial community present in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GB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itor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rvae. Each point represents the bacterial community composition of an individual larva. Different colours represent the 3 diet types whereas different dot shapes represent the zinc concentration that were fed to the larvae. The axis labels indicate the percentage of variation captured by each dimension. </a:t>
            </a:r>
          </a:p>
        </p:txBody>
      </p:sp>
      <p:pic>
        <p:nvPicPr>
          <p:cNvPr id="5" name="Picture 4" descr="A graph with different colored squares&#10;&#10;AI-generated content may be incorrect.">
            <a:extLst>
              <a:ext uri="{FF2B5EF4-FFF2-40B4-BE49-F238E27FC236}">
                <a16:creationId xmlns:a16="http://schemas.microsoft.com/office/drawing/2014/main" id="{D0B39CF2-8CBC-7A33-ED44-8268DD2B2A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1478" y="135"/>
            <a:ext cx="6789044" cy="5657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8844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D713AF-B55B-E94A-CA83-0AD5C69CCA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FA78684-583A-AB87-8A55-022825F7E240}"/>
              </a:ext>
            </a:extLst>
          </p:cNvPr>
          <p:cNvSpPr txBox="1"/>
          <p:nvPr/>
        </p:nvSpPr>
        <p:spPr>
          <a:xfrm>
            <a:off x="3149328" y="5037667"/>
            <a:ext cx="5893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le S3 – </a:t>
            </a:r>
            <a:r>
              <a:rPr lang="en-GB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conditions for GC-MS measurement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C6CBC81-834E-6315-5159-E077012B7F53}"/>
              </a:ext>
            </a:extLst>
          </p:cNvPr>
          <p:cNvGraphicFramePr>
            <a:graphicFrameLocks/>
          </p:cNvGraphicFramePr>
          <p:nvPr/>
        </p:nvGraphicFramePr>
        <p:xfrm>
          <a:off x="3622992" y="1096482"/>
          <a:ext cx="4811396" cy="3039435"/>
        </p:xfrm>
        <a:graphic>
          <a:graphicData uri="http://schemas.openxmlformats.org/drawingml/2006/table">
            <a:tbl>
              <a:tblPr firstRow="1" firstCol="1" bandRow="1"/>
              <a:tblGrid>
                <a:gridCol w="1716723">
                  <a:extLst>
                    <a:ext uri="{9D8B030D-6E8A-4147-A177-3AD203B41FA5}">
                      <a16:colId xmlns:a16="http://schemas.microsoft.com/office/drawing/2014/main" val="2282921428"/>
                    </a:ext>
                  </a:extLst>
                </a:gridCol>
                <a:gridCol w="3094673">
                  <a:extLst>
                    <a:ext uri="{9D8B030D-6E8A-4147-A177-3AD203B41FA5}">
                      <a16:colId xmlns:a16="http://schemas.microsoft.com/office/drawing/2014/main" val="71845714"/>
                    </a:ext>
                  </a:extLst>
                </a:gridCol>
              </a:tblGrid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C-MS system 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GC 2010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7091557"/>
                  </a:ext>
                </a:extLst>
              </a:tr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Mass detector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QP2010 plus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7056916"/>
                  </a:ext>
                </a:extLst>
              </a:tr>
              <a:tr h="25311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tationary phase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gilent HP-5-MS UI (30 m x 0.25 mm, 0.25 µm)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4880646"/>
                  </a:ext>
                </a:extLst>
              </a:tr>
              <a:tr h="24553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oftware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</a:t>
                      </a:r>
                      <a:r>
                        <a:rPr lang="en-GB" sz="110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CMSsolution</a:t>
                      </a: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Version 2.71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5564554"/>
                  </a:ext>
                </a:extLst>
              </a:tr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Autosampler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AOC20i+s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077375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Carrier gas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Hydrogen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04192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Column flow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.38 mL/min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465321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plit ratio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plitless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5775241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jection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50 °C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6970077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terface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70 °C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465218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on source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00 °C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3487633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jection volum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 µL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5543646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Electron voltag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70 eV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897134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Mass scanning rang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i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3–650 m/z</a:t>
                      </a:r>
                      <a:endParaRPr lang="en-GB" sz="1100" i="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395808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F89D704-C7F3-B083-9BA2-9832161E64DE}"/>
              </a:ext>
            </a:extLst>
          </p:cNvPr>
          <p:cNvGraphicFramePr>
            <a:graphicFrameLocks/>
          </p:cNvGraphicFramePr>
          <p:nvPr/>
        </p:nvGraphicFramePr>
        <p:xfrm>
          <a:off x="3622992" y="4251512"/>
          <a:ext cx="4811395" cy="670560"/>
        </p:xfrm>
        <a:graphic>
          <a:graphicData uri="http://schemas.openxmlformats.org/drawingml/2006/table">
            <a:tbl>
              <a:tblPr firstRow="1" firstCol="1" bandRow="1"/>
              <a:tblGrid>
                <a:gridCol w="1884698">
                  <a:extLst>
                    <a:ext uri="{9D8B030D-6E8A-4147-A177-3AD203B41FA5}">
                      <a16:colId xmlns:a16="http://schemas.microsoft.com/office/drawing/2014/main" val="1135500320"/>
                    </a:ext>
                  </a:extLst>
                </a:gridCol>
                <a:gridCol w="1525830">
                  <a:extLst>
                    <a:ext uri="{9D8B030D-6E8A-4147-A177-3AD203B41FA5}">
                      <a16:colId xmlns:a16="http://schemas.microsoft.com/office/drawing/2014/main" val="174207349"/>
                    </a:ext>
                  </a:extLst>
                </a:gridCol>
                <a:gridCol w="1400867">
                  <a:extLst>
                    <a:ext uri="{9D8B030D-6E8A-4147-A177-3AD203B41FA5}">
                      <a16:colId xmlns:a16="http://schemas.microsoft.com/office/drawing/2014/main" val="10823109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Temperature rise (°C/min.)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et temperature (°C)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Holding time (min.)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2566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– 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0570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90 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5554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89274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056762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5DEF71-E5C9-38E7-9B37-A2771BC031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C97734F-DCCC-55A3-A7BE-62E645C932D9}"/>
              </a:ext>
            </a:extLst>
          </p:cNvPr>
          <p:cNvSpPr txBox="1"/>
          <p:nvPr/>
        </p:nvSpPr>
        <p:spPr>
          <a:xfrm>
            <a:off x="1754623" y="5037667"/>
            <a:ext cx="8682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le S4 – </a:t>
            </a:r>
            <a:r>
              <a:rPr lang="en-GB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conditions for GC-MS measurements to identify volatile compounds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20D7CD5-7155-B491-564B-25A7F44E2534}"/>
              </a:ext>
            </a:extLst>
          </p:cNvPr>
          <p:cNvGraphicFramePr>
            <a:graphicFrameLocks/>
          </p:cNvGraphicFramePr>
          <p:nvPr/>
        </p:nvGraphicFramePr>
        <p:xfrm>
          <a:off x="3618862" y="1096482"/>
          <a:ext cx="4954271" cy="3039435"/>
        </p:xfrm>
        <a:graphic>
          <a:graphicData uri="http://schemas.openxmlformats.org/drawingml/2006/table">
            <a:tbl>
              <a:tblPr firstRow="1" firstCol="1" bandRow="1"/>
              <a:tblGrid>
                <a:gridCol w="1716723">
                  <a:extLst>
                    <a:ext uri="{9D8B030D-6E8A-4147-A177-3AD203B41FA5}">
                      <a16:colId xmlns:a16="http://schemas.microsoft.com/office/drawing/2014/main" val="2282921428"/>
                    </a:ext>
                  </a:extLst>
                </a:gridCol>
                <a:gridCol w="3237548">
                  <a:extLst>
                    <a:ext uri="{9D8B030D-6E8A-4147-A177-3AD203B41FA5}">
                      <a16:colId xmlns:a16="http://schemas.microsoft.com/office/drawing/2014/main" val="71845714"/>
                    </a:ext>
                  </a:extLst>
                </a:gridCol>
              </a:tblGrid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C-MS system 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GC-17A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7091557"/>
                  </a:ext>
                </a:extLst>
              </a:tr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Mass detector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QP2020 NX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7056916"/>
                  </a:ext>
                </a:extLst>
              </a:tr>
              <a:tr h="25311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tationary phase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estek Rtx®-Volatiles (60 m x 0.25 mm, 0.25 µm)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4880646"/>
                  </a:ext>
                </a:extLst>
              </a:tr>
              <a:tr h="24553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oftware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imadzu </a:t>
                      </a:r>
                      <a:r>
                        <a:rPr lang="en-GB" sz="110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CMSsolution</a:t>
                      </a: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Version 4.53SP1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5564554"/>
                  </a:ext>
                </a:extLst>
              </a:tr>
              <a:tr h="2248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Autosampler</a:t>
                      </a:r>
                      <a:endParaRPr lang="en-GB" sz="12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xel Semrau Combi-PAL-RSI </a:t>
                      </a:r>
                      <a:endParaRPr lang="en-GB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077375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Carrier gas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Hydrogen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04192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Column flow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.69 mL/min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465321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plit ratio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:20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5775241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jection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30 °C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6970077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terface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30 °C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465218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on source temperatur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00 °C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3487633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Injection volum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 mL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5543646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Electron voltag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70 eV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8971342"/>
                  </a:ext>
                </a:extLst>
              </a:tr>
              <a:tr h="207373">
                <a:tc>
                  <a:txBody>
                    <a:bodyPr/>
                    <a:lstStyle/>
                    <a:p>
                      <a:pPr algn="ctr"/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Mass scanning range</a:t>
                      </a:r>
                      <a:endParaRPr lang="en-GB" sz="1100" b="1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i="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3–350 m/z</a:t>
                      </a:r>
                      <a:endParaRPr lang="en-GB" sz="1100" i="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395808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483414CC-28DB-7429-C58E-1BDAFBB78796}"/>
              </a:ext>
            </a:extLst>
          </p:cNvPr>
          <p:cNvGraphicFramePr>
            <a:graphicFrameLocks/>
          </p:cNvGraphicFramePr>
          <p:nvPr/>
        </p:nvGraphicFramePr>
        <p:xfrm>
          <a:off x="3618861" y="4251512"/>
          <a:ext cx="4954271" cy="670560"/>
        </p:xfrm>
        <a:graphic>
          <a:graphicData uri="http://schemas.openxmlformats.org/drawingml/2006/table">
            <a:tbl>
              <a:tblPr firstRow="1" firstCol="1" bandRow="1"/>
              <a:tblGrid>
                <a:gridCol w="1940666">
                  <a:extLst>
                    <a:ext uri="{9D8B030D-6E8A-4147-A177-3AD203B41FA5}">
                      <a16:colId xmlns:a16="http://schemas.microsoft.com/office/drawing/2014/main" val="1135500320"/>
                    </a:ext>
                  </a:extLst>
                </a:gridCol>
                <a:gridCol w="1571139">
                  <a:extLst>
                    <a:ext uri="{9D8B030D-6E8A-4147-A177-3AD203B41FA5}">
                      <a16:colId xmlns:a16="http://schemas.microsoft.com/office/drawing/2014/main" val="174207349"/>
                    </a:ext>
                  </a:extLst>
                </a:gridCol>
                <a:gridCol w="1442466">
                  <a:extLst>
                    <a:ext uri="{9D8B030D-6E8A-4147-A177-3AD203B41FA5}">
                      <a16:colId xmlns:a16="http://schemas.microsoft.com/office/drawing/2014/main" val="10823109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Temperature rise [°C/min]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et temperature [°C]</a:t>
                      </a:r>
                      <a:endParaRPr lang="en-GB" sz="1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Holding time [min]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2566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0570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5554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98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–</a:t>
                      </a:r>
                      <a:endParaRPr lang="en-GB" sz="1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89274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05551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93AC47-C5DB-E5DF-261D-3FEAAF6999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FDB662E-06FA-A75C-ABC0-53D2B48767D1}"/>
              </a:ext>
            </a:extLst>
          </p:cNvPr>
          <p:cNvSpPr txBox="1"/>
          <p:nvPr/>
        </p:nvSpPr>
        <p:spPr>
          <a:xfrm>
            <a:off x="0" y="5140961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ble S5 – </a:t>
            </a:r>
            <a:r>
              <a:rPr lang="en-GB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onis pairwise comparison of Bray-Curtis dissimilarity estimation of the composition of the bacterial community present in </a:t>
            </a:r>
            <a:r>
              <a:rPr lang="en-GB" sz="1600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GB" sz="1600" b="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itor</a:t>
            </a:r>
            <a:r>
              <a:rPr lang="en-GB" sz="16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arvae after 35-day feeding trials. Significant comparisons are in bold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32EE0FA-DDE7-8AE2-0B2D-922A8D939242}"/>
              </a:ext>
            </a:extLst>
          </p:cNvPr>
          <p:cNvGraphicFramePr>
            <a:graphicFrameLocks noGrp="1"/>
          </p:cNvGraphicFramePr>
          <p:nvPr/>
        </p:nvGraphicFramePr>
        <p:xfrm>
          <a:off x="1979771" y="2312670"/>
          <a:ext cx="8232458" cy="2232660"/>
        </p:xfrm>
        <a:graphic>
          <a:graphicData uri="http://schemas.openxmlformats.org/drawingml/2006/table">
            <a:tbl>
              <a:tblPr/>
              <a:tblGrid>
                <a:gridCol w="1103630">
                  <a:extLst>
                    <a:ext uri="{9D8B030D-6E8A-4147-A177-3AD203B41FA5}">
                      <a16:colId xmlns:a16="http://schemas.microsoft.com/office/drawing/2014/main" val="2043494669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1615906498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3731901261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712850858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3854408877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463506320"/>
                    </a:ext>
                  </a:extLst>
                </a:gridCol>
                <a:gridCol w="1147128">
                  <a:extLst>
                    <a:ext uri="{9D8B030D-6E8A-4147-A177-3AD203B41FA5}">
                      <a16:colId xmlns:a16="http://schemas.microsoft.com/office/drawing/2014/main" val="4171941831"/>
                    </a:ext>
                  </a:extLst>
                </a:gridCol>
              </a:tblGrid>
              <a:tr h="2667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p-valu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baseline="-25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04304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C0C0C0"/>
                          </a:highlight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18364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4178, 0.001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64319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baseline="-250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236, 0.00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549, 0.4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1475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312, 0.001</a:t>
                      </a: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864, 0.2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792, 0.108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808080"/>
                        </a:highlight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07183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24, 0.001</a:t>
                      </a: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138, 0.74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25, 0.435</a:t>
                      </a: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468, 0.26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26662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094, 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299, 0.17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r>
                        <a:rPr lang="pt-P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846, 0.05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673, 0.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06, 0.66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56429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/>
                      <a:r>
                        <a:rPr lang="en-GB" sz="14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+ </a:t>
                      </a:r>
                      <a:r>
                        <a:rPr lang="en-GB" sz="1400" b="0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</a:t>
                      </a:r>
                      <a:r>
                        <a:rPr lang="en-GB" sz="1400" b="0" i="0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55, 0.00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3564, 0.01</a:t>
                      </a: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579, 0.024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493, 0.002</a:t>
                      </a: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593, 0.017</a:t>
                      </a:r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797, 0.00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04711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420866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68A8E65-F072-2EE5-AE2E-050D4A664B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0253402-A3BA-29A6-DA9B-AC30C78DFBBE}"/>
              </a:ext>
            </a:extLst>
          </p:cNvPr>
          <p:cNvSpPr txBox="1"/>
          <p:nvPr/>
        </p:nvSpPr>
        <p:spPr>
          <a:xfrm>
            <a:off x="0" y="5158815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 –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pcharts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ing the normalized counts of the 16S amplicons of the 10 genera detected as being differentially abundant between treatment groups (x-axis). Each panel contains the data relative to one single member of the genera stated above the plot window. Each dot represents the counts of an individual sample.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A05F075-59C8-EECC-D3CD-AEEE355043D3}"/>
              </a:ext>
            </a:extLst>
          </p:cNvPr>
          <p:cNvGrpSpPr/>
          <p:nvPr/>
        </p:nvGrpSpPr>
        <p:grpSpPr>
          <a:xfrm>
            <a:off x="44450" y="-4"/>
            <a:ext cx="12103100" cy="4972054"/>
            <a:chOff x="103411" y="-3"/>
            <a:chExt cx="11985176" cy="4794068"/>
          </a:xfrm>
        </p:grpSpPr>
        <p:pic>
          <p:nvPicPr>
            <p:cNvPr id="5" name="Picture 4" descr="A graph of a number of cells&#10;&#10;AI-generated content may be incorrect.">
              <a:extLst>
                <a:ext uri="{FF2B5EF4-FFF2-40B4-BE49-F238E27FC236}">
                  <a16:creationId xmlns:a16="http://schemas.microsoft.com/office/drawing/2014/main" id="{6D96B932-968D-A752-789E-2BF1EC7B2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411" y="0"/>
              <a:ext cx="2397034" cy="2397034"/>
            </a:xfrm>
            <a:prstGeom prst="rect">
              <a:avLst/>
            </a:prstGeom>
          </p:spPr>
        </p:pic>
        <p:pic>
          <p:nvPicPr>
            <p:cNvPr id="7" name="Picture 6" descr="A graph showing the number of bacteria&#10;&#10;AI-generated content may be incorrect.">
              <a:extLst>
                <a:ext uri="{FF2B5EF4-FFF2-40B4-BE49-F238E27FC236}">
                  <a16:creationId xmlns:a16="http://schemas.microsoft.com/office/drawing/2014/main" id="{F4C7D6AB-AFF2-7C6B-5D0E-47C9322DABC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0448" y="-1"/>
              <a:ext cx="2397034" cy="2397034"/>
            </a:xfrm>
            <a:prstGeom prst="rect">
              <a:avLst/>
            </a:prstGeom>
          </p:spPr>
        </p:pic>
        <p:pic>
          <p:nvPicPr>
            <p:cNvPr id="9" name="Picture 8" descr="A graph of a number of cells&#10;&#10;AI-generated content may be incorrect.">
              <a:extLst>
                <a:ext uri="{FF2B5EF4-FFF2-40B4-BE49-F238E27FC236}">
                  <a16:creationId xmlns:a16="http://schemas.microsoft.com/office/drawing/2014/main" id="{8DF467A5-C507-67B3-8DBC-8B41A093CF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97474" y="0"/>
              <a:ext cx="2397034" cy="2397034"/>
            </a:xfrm>
            <a:prstGeom prst="rect">
              <a:avLst/>
            </a:prstGeom>
          </p:spPr>
        </p:pic>
        <p:pic>
          <p:nvPicPr>
            <p:cNvPr id="11" name="Picture 10" descr="A graph with numbers and dots&#10;&#10;AI-generated content may be incorrect.">
              <a:extLst>
                <a:ext uri="{FF2B5EF4-FFF2-40B4-BE49-F238E27FC236}">
                  <a16:creationId xmlns:a16="http://schemas.microsoft.com/office/drawing/2014/main" id="{EDECAEB1-4243-C799-50AB-527B5D16B17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4512" y="-3"/>
              <a:ext cx="2397035" cy="2397035"/>
            </a:xfrm>
            <a:prstGeom prst="rect">
              <a:avLst/>
            </a:prstGeom>
          </p:spPr>
        </p:pic>
        <p:pic>
          <p:nvPicPr>
            <p:cNvPr id="13" name="Picture 12" descr="A graph with numbers and dots&#10;&#10;AI-generated content may be incorrect.">
              <a:extLst>
                <a:ext uri="{FF2B5EF4-FFF2-40B4-BE49-F238E27FC236}">
                  <a16:creationId xmlns:a16="http://schemas.microsoft.com/office/drawing/2014/main" id="{48449266-8615-390D-45A2-A212BD1243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91551" y="-2"/>
              <a:ext cx="2397035" cy="2397035"/>
            </a:xfrm>
            <a:prstGeom prst="rect">
              <a:avLst/>
            </a:prstGeom>
          </p:spPr>
        </p:pic>
        <p:pic>
          <p:nvPicPr>
            <p:cNvPr id="15" name="Picture 14" descr="A graph of a sample&#10;&#10;AI-generated content may be incorrect.">
              <a:extLst>
                <a:ext uri="{FF2B5EF4-FFF2-40B4-BE49-F238E27FC236}">
                  <a16:creationId xmlns:a16="http://schemas.microsoft.com/office/drawing/2014/main" id="{179E87DC-9438-50FE-EC2D-072A1258EEC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414" y="2397032"/>
              <a:ext cx="2397033" cy="2397033"/>
            </a:xfrm>
            <a:prstGeom prst="rect">
              <a:avLst/>
            </a:prstGeom>
          </p:spPr>
        </p:pic>
        <p:pic>
          <p:nvPicPr>
            <p:cNvPr id="17" name="Picture 16" descr="A graph of a number of cells&#10;&#10;AI-generated content may be incorrect.">
              <a:extLst>
                <a:ext uri="{FF2B5EF4-FFF2-40B4-BE49-F238E27FC236}">
                  <a16:creationId xmlns:a16="http://schemas.microsoft.com/office/drawing/2014/main" id="{A6A75E3D-1752-207C-D80C-641DD3C21B1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0447" y="2395831"/>
              <a:ext cx="2397033" cy="2397033"/>
            </a:xfrm>
            <a:prstGeom prst="rect">
              <a:avLst/>
            </a:prstGeom>
          </p:spPr>
        </p:pic>
        <p:pic>
          <p:nvPicPr>
            <p:cNvPr id="19" name="Picture 18" descr="A graph of a number of bacteria&#10;&#10;AI-generated content may be incorrect.">
              <a:extLst>
                <a:ext uri="{FF2B5EF4-FFF2-40B4-BE49-F238E27FC236}">
                  <a16:creationId xmlns:a16="http://schemas.microsoft.com/office/drawing/2014/main" id="{5C378D3A-FCE7-7288-7633-D95DABCF4C4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90735" y="2389693"/>
              <a:ext cx="2403771" cy="2403771"/>
            </a:xfrm>
            <a:prstGeom prst="rect">
              <a:avLst/>
            </a:prstGeom>
          </p:spPr>
        </p:pic>
        <p:pic>
          <p:nvPicPr>
            <p:cNvPr id="21" name="Picture 20" descr="A graph with black dots&#10;&#10;AI-generated content may be incorrect.">
              <a:extLst>
                <a:ext uri="{FF2B5EF4-FFF2-40B4-BE49-F238E27FC236}">
                  <a16:creationId xmlns:a16="http://schemas.microsoft.com/office/drawing/2014/main" id="{2586DD86-194E-355B-BE8D-C062D7AA21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4512" y="2395829"/>
              <a:ext cx="2397033" cy="2397033"/>
            </a:xfrm>
            <a:prstGeom prst="rect">
              <a:avLst/>
            </a:prstGeom>
          </p:spPr>
        </p:pic>
        <p:pic>
          <p:nvPicPr>
            <p:cNvPr id="23" name="Picture 22" descr="A graph with numbers and dots&#10;&#10;AI-generated content may be incorrect.">
              <a:extLst>
                <a:ext uri="{FF2B5EF4-FFF2-40B4-BE49-F238E27FC236}">
                  <a16:creationId xmlns:a16="http://schemas.microsoft.com/office/drawing/2014/main" id="{B64DF8CA-0EA7-E4EF-95B7-6D365DC20A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91548" y="2396427"/>
              <a:ext cx="2397039" cy="23970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690193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A32482-4EE8-EEAE-91F1-C060B89C462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E6CDEDC-7BE5-F86E-BD38-1A7A549B1382}"/>
              </a:ext>
            </a:extLst>
          </p:cNvPr>
          <p:cNvSpPr txBox="1"/>
          <p:nvPr/>
        </p:nvSpPr>
        <p:spPr>
          <a:xfrm>
            <a:off x="0" y="6017483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2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cke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plot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ing the relative abundance of the most abundant bacterial genera detected in colonies isolated from fermented spinach in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i-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ve MRS agar. Each bar represents an individual sample.</a:t>
            </a:r>
          </a:p>
        </p:txBody>
      </p:sp>
      <p:pic>
        <p:nvPicPr>
          <p:cNvPr id="4" name="Picture 3" descr="A red and black vertical lines&#10;&#10;AI-generated content may be incorrect.">
            <a:extLst>
              <a:ext uri="{FF2B5EF4-FFF2-40B4-BE49-F238E27FC236}">
                <a16:creationId xmlns:a16="http://schemas.microsoft.com/office/drawing/2014/main" id="{8976CC1E-7F0E-4143-6B28-EFCD1374A1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3474" y="0"/>
            <a:ext cx="1805245" cy="6017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65554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F03F68-F447-EF6D-2B3F-BCECA728FE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C03A8DE-BECC-5C0B-E220-0C006EF341D2}"/>
              </a:ext>
            </a:extLst>
          </p:cNvPr>
          <p:cNvSpPr txBox="1"/>
          <p:nvPr/>
        </p:nvSpPr>
        <p:spPr>
          <a:xfrm>
            <a:off x="1" y="5657671"/>
            <a:ext cx="12191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3 –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ordinates analysis (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 visualizing Bray-Curtis dissimilarity of the composition of the bacterial community present in substrate/spinach samples. Each point represents the composition of an individual sample, and each colour represents a treatment group. The axis labels indicate the percentage of variation captured by each dimension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45CFBE8-F137-17E3-18BB-E77AF9D3D9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0880" y="-861"/>
            <a:ext cx="6790239" cy="56585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32385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11549F-61A6-9FBC-2032-533140C411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graph with lines and dots&#10;&#10;AI-generated content may be incorrect.">
            <a:extLst>
              <a:ext uri="{FF2B5EF4-FFF2-40B4-BE49-F238E27FC236}">
                <a16:creationId xmlns:a16="http://schemas.microsoft.com/office/drawing/2014/main" id="{E788105F-E33E-61ED-2EF1-10BD665A1A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6212" y="1123373"/>
            <a:ext cx="6112212" cy="42423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9927CB-33FF-1193-9061-77BD8FCFFEF2}"/>
              </a:ext>
            </a:extLst>
          </p:cNvPr>
          <p:cNvSpPr txBox="1"/>
          <p:nvPr/>
        </p:nvSpPr>
        <p:spPr>
          <a:xfrm>
            <a:off x="0" y="5551509"/>
            <a:ext cx="121919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4- Effect 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ots of dry matter (%) in 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inach samples (F</a:t>
            </a:r>
            <a:r>
              <a:rPr lang="en-GB" sz="1600" i="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,8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= 7.964, p = 0.0087) and in all formulated diets (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6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,11</a:t>
            </a:r>
            <a:r>
              <a:rPr lang="en-GB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12.45,</a:t>
            </a:r>
            <a:r>
              <a:rPr lang="en-GB" sz="16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 = 0.0002). Dots show mean predicted values with 95% confidence intervals. 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a diet&#10;&#10;AI-generated content may be incorrect.">
            <a:extLst>
              <a:ext uri="{FF2B5EF4-FFF2-40B4-BE49-F238E27FC236}">
                <a16:creationId xmlns:a16="http://schemas.microsoft.com/office/drawing/2014/main" id="{74D69E5F-A839-4F2D-745E-AB77C14B20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123373"/>
            <a:ext cx="6096000" cy="4242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6291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26</Words>
  <Application>Microsoft Office PowerPoint</Application>
  <PresentationFormat>Widescreen</PresentationFormat>
  <Paragraphs>193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RNARDO PAIVA ANTUNES</dc:creator>
  <cp:lastModifiedBy>BERNARDO PAIVA ANTUNES</cp:lastModifiedBy>
  <cp:revision>1</cp:revision>
  <dcterms:created xsi:type="dcterms:W3CDTF">2025-08-04T15:22:11Z</dcterms:created>
  <dcterms:modified xsi:type="dcterms:W3CDTF">2025-08-04T15:24:04Z</dcterms:modified>
</cp:coreProperties>
</file>